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42223"/>
    <a:srgbClr val="27232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00" d="100"/>
          <a:sy n="100" d="100"/>
        </p:scale>
        <p:origin x="72" y="2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51B20C-C081-486B-8847-0A8F517DF7E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659D4D9-E4DC-4F11-A473-FC939D860E6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SG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421328-F33A-4442-82C8-7BFDC4430C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9317E-9A62-4152-AAE8-0C751AD8C7A3}" type="datetimeFigureOut">
              <a:rPr lang="en-SG" smtClean="0"/>
              <a:t>31/3/2023</a:t>
            </a:fld>
            <a:endParaRPr lang="en-SG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631156-CE8B-4C9F-A09E-F40A268FDE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746306-E01C-48CD-8FD1-8DD1DF8F7B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C8378-2D69-4A19-B29F-878D7F19BF4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8383236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1FE7B0-6782-4249-9FA3-AC727753F1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83FD677-FB51-439C-917E-5D04DBD08A7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C58B88-87A8-4780-9953-5C27D2E96F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9317E-9A62-4152-AAE8-0C751AD8C7A3}" type="datetimeFigureOut">
              <a:rPr lang="en-SG" smtClean="0"/>
              <a:t>31/3/2023</a:t>
            </a:fld>
            <a:endParaRPr lang="en-SG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8B0238-698E-430D-91BE-703448C1CA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5C6F5B-8E7F-4F47-969B-052D865935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C8378-2D69-4A19-B29F-878D7F19BF4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7672343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5CBD032-6510-4BC7-B95E-A9058BDE63C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9FE8079-8B38-4316-AA49-934B432D543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62B47A-55B5-4892-808E-0B5A06E105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9317E-9A62-4152-AAE8-0C751AD8C7A3}" type="datetimeFigureOut">
              <a:rPr lang="en-SG" smtClean="0"/>
              <a:t>31/3/2023</a:t>
            </a:fld>
            <a:endParaRPr lang="en-SG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298DCE-3D4F-403B-B8FB-DD993F9201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73ED89-FD81-4B53-A53B-A12A16CA6C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C8378-2D69-4A19-B29F-878D7F19BF4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1941351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33E5CE-C147-4D70-B0CD-9AEED00EEB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5D8DCEE-DC20-4A33-B436-C5AE0159B03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CC359A-7D4F-49C4-B290-539EB0179E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9317E-9A62-4152-AAE8-0C751AD8C7A3}" type="datetimeFigureOut">
              <a:rPr lang="en-SG" smtClean="0"/>
              <a:t>31/3/2023</a:t>
            </a:fld>
            <a:endParaRPr lang="en-SG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56B410-6EE1-4F30-A14B-A91E82345B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D86FA5-4A61-4DDB-85D8-AB6B9A2B42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C8378-2D69-4A19-B29F-878D7F19BF4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4320526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FC640A-E1E9-4CD4-951C-C221919EAD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FA1EA2C-4E00-4C5E-A368-EFD9965933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7DA9EC-2707-4D1D-AF8C-C381410C6C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9317E-9A62-4152-AAE8-0C751AD8C7A3}" type="datetimeFigureOut">
              <a:rPr lang="en-SG" smtClean="0"/>
              <a:t>31/3/2023</a:t>
            </a:fld>
            <a:endParaRPr lang="en-SG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25E6DC-3DF3-433E-8B8F-FD9A841444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0F70D0-758C-4DD2-AE95-9E29E0C5FE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C8378-2D69-4A19-B29F-878D7F19BF4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087204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0B0369-6488-4972-9A96-B9214C2B8D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D1D6158-2868-4D72-8536-DB5C68F3444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EE93A4B-9867-4336-AAB5-B8ECEEFECAC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2E6A560-FFB3-4A71-BDD7-8D830549F9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9317E-9A62-4152-AAE8-0C751AD8C7A3}" type="datetimeFigureOut">
              <a:rPr lang="en-SG" smtClean="0"/>
              <a:t>31/3/2023</a:t>
            </a:fld>
            <a:endParaRPr lang="en-SG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65FE088-1FAC-4939-A3C8-2E51C18198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B944A9-5DF8-498A-8B1D-9A97CAA29C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C8378-2D69-4A19-B29F-878D7F19BF4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9793263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F848AB-4F34-4171-AEDF-D7F0C8067B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35004C1-4834-48A8-8525-AFBD41E881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C475A19-5B65-4D72-9913-E896294502A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4AB3DFC-057B-494F-950A-9AD2B794E3E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648D702-42BF-4578-86F6-F722F29EFA5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74D1BEF-2F17-4E76-9FDD-08D39FF28A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9317E-9A62-4152-AAE8-0C751AD8C7A3}" type="datetimeFigureOut">
              <a:rPr lang="en-SG" smtClean="0"/>
              <a:t>31/3/2023</a:t>
            </a:fld>
            <a:endParaRPr lang="en-SG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D173B1D-521E-48BD-B860-99FFA08E24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2B7554C-7974-4945-AAA6-E0CCDE5C1B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C8378-2D69-4A19-B29F-878D7F19BF4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865116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10124F-6D95-4639-BEA9-831CC6319A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1DCEF57-789D-42CD-BEC0-588CE7CB5D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9317E-9A62-4152-AAE8-0C751AD8C7A3}" type="datetimeFigureOut">
              <a:rPr lang="en-SG" smtClean="0"/>
              <a:t>31/3/2023</a:t>
            </a:fld>
            <a:endParaRPr lang="en-SG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DC4C2AA-D7DA-45B4-B614-38FC25FD6C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2BE281D-C536-4BEF-B9B9-E61552972D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C8378-2D69-4A19-B29F-878D7F19BF4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41247487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8FA2E95-BC42-4E5F-B058-42780591F9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9317E-9A62-4152-AAE8-0C751AD8C7A3}" type="datetimeFigureOut">
              <a:rPr lang="en-SG" smtClean="0"/>
              <a:t>31/3/2023</a:t>
            </a:fld>
            <a:endParaRPr lang="en-SG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C2C41BC-6D4B-4089-B8F5-780E50CE36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301E045-BB52-4057-8B55-B63EF1FC21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C8378-2D69-4A19-B29F-878D7F19BF4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4880226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1E7287-7ACA-4D07-88E7-CE5458B3CF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A2B5B89-27BE-4313-81CC-90785E1B9A4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DB2CB19-EC70-416A-95DD-2FE75DF608B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DEF5FA-1EB5-4C07-ACF6-E150532569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9317E-9A62-4152-AAE8-0C751AD8C7A3}" type="datetimeFigureOut">
              <a:rPr lang="en-SG" smtClean="0"/>
              <a:t>31/3/2023</a:t>
            </a:fld>
            <a:endParaRPr lang="en-SG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A92572-E6FB-429F-B64B-5F762C48EF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751CC28-445A-45F6-9A71-17BACE78E0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C8378-2D69-4A19-B29F-878D7F19BF4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8589920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83D6D8-1F09-409E-B438-EA0526D04C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F3DD14D-12BD-474E-B0D1-29572CD61DA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SG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544EE01-4144-49D7-A859-05AA9EF5C9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641D0D-47F8-4BE6-A70C-66A6DA78D2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9317E-9A62-4152-AAE8-0C751AD8C7A3}" type="datetimeFigureOut">
              <a:rPr lang="en-SG" smtClean="0"/>
              <a:t>31/3/2023</a:t>
            </a:fld>
            <a:endParaRPr lang="en-SG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E0865BD-32A5-4BED-A747-8D5E5B01FB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A2951DD-F73A-468A-8D76-923F0C4B9C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C8378-2D69-4A19-B29F-878D7F19BF4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4409783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1906019-043D-40EF-A405-4BFFE00FB6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FD3CD6-6716-4D1F-9883-102705519A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B50186-A246-4B6A-9268-7FAC3946745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49317E-9A62-4152-AAE8-0C751AD8C7A3}" type="datetimeFigureOut">
              <a:rPr lang="en-SG" smtClean="0"/>
              <a:t>31/3/2023</a:t>
            </a:fld>
            <a:endParaRPr lang="en-SG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153A1B-E2C3-4276-863F-1191D1963B8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SG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5FCB68-7CD8-45CE-B59D-1D9B6E2A941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5C8378-2D69-4A19-B29F-878D7F19BF4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8414294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BD907A-DBFF-4DCB-A68F-99507D96A0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SG" dirty="0"/>
              <a:t>Additional File 1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0887604-636D-4E6E-B1CA-E9E6D59EE98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8055" y="2110154"/>
            <a:ext cx="3918438" cy="292231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B5BB3783-DEE8-452A-A8CE-D200B23B8591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92948" y="2110154"/>
            <a:ext cx="3210275" cy="2900047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805E881-5EF6-4A72-B67F-B7BED07B8DEB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43334" y="2110154"/>
            <a:ext cx="3210276" cy="288434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A8139D0-D812-4F11-B0B8-36A93F8B534A}"/>
              </a:ext>
            </a:extLst>
          </p:cNvPr>
          <p:cNvSpPr txBox="1"/>
          <p:nvPr/>
        </p:nvSpPr>
        <p:spPr>
          <a:xfrm>
            <a:off x="659004" y="1772719"/>
            <a:ext cx="38070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SG" sz="1400" dirty="0"/>
              <a:t>k = 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FEEE8D3-40A0-4B81-94EA-3CA2BF3E9BAD}"/>
              </a:ext>
            </a:extLst>
          </p:cNvPr>
          <p:cNvSpPr txBox="1"/>
          <p:nvPr/>
        </p:nvSpPr>
        <p:spPr>
          <a:xfrm>
            <a:off x="8713177" y="1772719"/>
            <a:ext cx="30620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SG" sz="1400" dirty="0"/>
              <a:t>k = 5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DF4BBCD-34CE-4C97-8EDE-4A79CEDF06B9}"/>
              </a:ext>
            </a:extLst>
          </p:cNvPr>
          <p:cNvSpPr txBox="1"/>
          <p:nvPr/>
        </p:nvSpPr>
        <p:spPr>
          <a:xfrm>
            <a:off x="5030830" y="1772719"/>
            <a:ext cx="31723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SG" sz="1400" dirty="0"/>
              <a:t>k = 4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C8ADB06-AE9F-40C2-BF93-C7DEDA995E3B}"/>
              </a:ext>
            </a:extLst>
          </p:cNvPr>
          <p:cNvSpPr txBox="1"/>
          <p:nvPr/>
        </p:nvSpPr>
        <p:spPr>
          <a:xfrm>
            <a:off x="659423" y="5371394"/>
            <a:ext cx="11115846" cy="77938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4000"/>
              </a:lnSpc>
              <a:spcAft>
                <a:spcPts val="1000"/>
              </a:spcAft>
            </a:pPr>
            <a:r>
              <a:rPr lang="en-SG" sz="1000" b="1" dirty="0"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Additional File 1. </a:t>
            </a:r>
            <a:r>
              <a:rPr lang="en-SG" sz="1000" b="1" dirty="0" err="1"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Subclustering</a:t>
            </a:r>
            <a:r>
              <a:rPr lang="en-SG" sz="1000" b="1" dirty="0"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 habenula phenotypes</a:t>
            </a:r>
            <a:r>
              <a:rPr lang="en-SG" sz="1000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. (A-C) Phenotypes obtained by clustering dorsal and ventral habenula cells using k-means clustering for different values of cluster numbers (k). Figure 1F of the main text shows results </a:t>
            </a:r>
            <a:r>
              <a:rPr lang="en-SG" sz="1000" dirty="0"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o</a:t>
            </a:r>
            <a:r>
              <a:rPr lang="en-SG" sz="1000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btained when using a k value of 3 (used in the rest of the paper). It can be seen that while using k = 3 adds a new type of behaviour (V-OFF-Tonic and V-OFF-Phasic) compared to using k = 2, increasing cluster size further to 4 and 5 changes only the magnitude of responses or acclimation to repetition, but does not result in qualitatively new </a:t>
            </a:r>
            <a:r>
              <a:rPr lang="en-SG" sz="1000" dirty="0" err="1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behaviors</a:t>
            </a:r>
            <a:r>
              <a:rPr lang="en-SG" sz="1000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 within a single light and dark period. 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3B08C9A2-3CD5-477F-8236-B7F65018EB91}"/>
              </a:ext>
            </a:extLst>
          </p:cNvPr>
          <p:cNvSpPr/>
          <p:nvPr/>
        </p:nvSpPr>
        <p:spPr>
          <a:xfrm>
            <a:off x="312385" y="1659387"/>
            <a:ext cx="471340" cy="4095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SG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5C9F20BC-C47A-455B-9666-13040D5AB4AF}"/>
              </a:ext>
            </a:extLst>
          </p:cNvPr>
          <p:cNvSpPr/>
          <p:nvPr/>
        </p:nvSpPr>
        <p:spPr>
          <a:xfrm>
            <a:off x="4694477" y="1659387"/>
            <a:ext cx="471340" cy="4095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SG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DCB99CA9-5A45-4845-97E7-0A74DE88CEBD}"/>
              </a:ext>
            </a:extLst>
          </p:cNvPr>
          <p:cNvSpPr/>
          <p:nvPr/>
        </p:nvSpPr>
        <p:spPr>
          <a:xfrm>
            <a:off x="8269604" y="1659387"/>
            <a:ext cx="471340" cy="4095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SG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9027171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752</TotalTime>
  <Words>135</Words>
  <Application>Microsoft Office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Additional File 1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rendra Suhas Jagannathan</dc:creator>
  <cp:lastModifiedBy>Narendra Suhas Jagannathan</cp:lastModifiedBy>
  <cp:revision>71</cp:revision>
  <dcterms:created xsi:type="dcterms:W3CDTF">2022-09-06T02:43:51Z</dcterms:created>
  <dcterms:modified xsi:type="dcterms:W3CDTF">2023-03-31T11:46:41Z</dcterms:modified>
</cp:coreProperties>
</file>